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 uri="{1BD7E111-0CB8-44D6-8891-C1BB2F81B7CC}">
      <p1710:readonlyRecommended xmlns:p1710="http://schemas.microsoft.com/office/powerpoint/2017/10/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7" d="100"/>
          <a:sy n="87" d="100"/>
        </p:scale>
        <p:origin x="422" y="77"/>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B71360-DB91-C44E-563E-AF7E24C534C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FE945C1-41BB-07C5-FC5C-B5B78C712C3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CFF0D41-61CA-911E-AEC0-441503E70EBC}"/>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18D4D7F5-9F29-9B22-6994-E672928E94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1A75AC-CD2A-E826-E319-3ED802D1AEDB}"/>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25187347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9FB159-E515-426C-8089-40DFB626008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5029DA4-5D0B-814B-8109-948149C6011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0CB49A-094F-97B3-5D3E-B11F46CA11F5}"/>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92E1EBDD-9587-4411-F4CC-D2DD154639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55D64A-91F0-753D-6B04-2A88E2E73828}"/>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16377912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6ED8407-3536-0131-B774-2A7AE88EF7C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E54CD66-C81B-7DBF-44DA-88E3FFD398D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DEE3C4-7F21-A2B7-824A-B8F03FC9071E}"/>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F633C0A5-4C49-312B-0763-46EBD2695D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60A580-6E0C-4362-F4EF-7A87C20E62B2}"/>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14363199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9AC21D-3FE0-CD9B-57CD-3B53D6E5E7D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018B6EA-7E8F-2764-7276-8A357550FF8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3FE585-A213-87C8-5DC7-4692BE96F07D}"/>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F6A72480-3537-7184-F5C9-0E7B2D27B7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406E68-8682-00BD-EBB7-93C0F81D2061}"/>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1758165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4D93B7-E925-2B90-4168-FF20C44E044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D773BAC-FDC0-8FAD-69BE-2A82B6FEC8D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041CA31-970A-6C41-7CE8-0734853D10E4}"/>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C09E3257-47EF-875F-FD97-6EEC6745C7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6D9FF4-D6D6-51F3-1243-7351DC32F808}"/>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26528512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81971A-C79D-D21E-6D9D-F422000899B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46B4F82-BC9F-0773-46A7-10064FBF10D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EEEFEAB-43B7-E6B5-3C98-7EFA2835C3C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3D1C058-6C73-6E1D-C8FC-DCD158B2278D}"/>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6" name="Footer Placeholder 5">
            <a:extLst>
              <a:ext uri="{FF2B5EF4-FFF2-40B4-BE49-F238E27FC236}">
                <a16:creationId xmlns:a16="http://schemas.microsoft.com/office/drawing/2014/main" id="{FB526E57-C9A8-BF2F-7B93-99AE6EF185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9FD8C7-556B-4045-F1D1-07D7CF736EAC}"/>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3671218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053C3D-D6C8-C8CA-D895-2B8BA33FEA0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9B45046-1E36-B8D3-EF33-5C477ECBD9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EEB0214-B3CF-2D69-170D-83B326779CA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9A03142-7F87-F7E2-3B37-973BB06B649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E4B28C1-7221-CB12-4EDC-B1810BE5601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3928D95-56E0-7F5F-329A-2BCA4D072D7C}"/>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8" name="Footer Placeholder 7">
            <a:extLst>
              <a:ext uri="{FF2B5EF4-FFF2-40B4-BE49-F238E27FC236}">
                <a16:creationId xmlns:a16="http://schemas.microsoft.com/office/drawing/2014/main" id="{5186483C-6654-C328-9EEB-6259F50AB15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926AE3F-9CD4-687F-C701-4E92BB8E6C15}"/>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4312416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27376B-AFCD-5D4A-0512-A6FEE925704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8A27F0C-201F-E587-E2DE-51F173623024}"/>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4" name="Footer Placeholder 3">
            <a:extLst>
              <a:ext uri="{FF2B5EF4-FFF2-40B4-BE49-F238E27FC236}">
                <a16:creationId xmlns:a16="http://schemas.microsoft.com/office/drawing/2014/main" id="{83FE394F-EF13-BF8C-6232-6B9E573228F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190592B-337F-10F7-5E24-C50C16E77317}"/>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39764958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C114EED-76F0-33C3-146C-54EBB48AEF36}"/>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3" name="Footer Placeholder 2">
            <a:extLst>
              <a:ext uri="{FF2B5EF4-FFF2-40B4-BE49-F238E27FC236}">
                <a16:creationId xmlns:a16="http://schemas.microsoft.com/office/drawing/2014/main" id="{7BF42585-52F2-0739-60B3-B316E2C1702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28DA603-AD6A-E8ED-2F18-1EFC5770609C}"/>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4065397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D99424-85C7-4DBA-B59E-A40BCECAAC8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7ABCF50-24DE-8191-D05B-287E9956C25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CDC4EC2-0630-A84F-43F2-A5CCB2E4CA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6BC59DB-D0A4-8D2C-3141-CB7773356ED1}"/>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6" name="Footer Placeholder 5">
            <a:extLst>
              <a:ext uri="{FF2B5EF4-FFF2-40B4-BE49-F238E27FC236}">
                <a16:creationId xmlns:a16="http://schemas.microsoft.com/office/drawing/2014/main" id="{ED315856-9EA9-F6F5-E0F3-AD2298006B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0AA50AB-F2E3-E33D-208D-421829EBBBBD}"/>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6530489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F0F18A-B8EB-4B9A-AD68-244426363E2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A434846-3699-ECC6-FB1C-E20DBFD0709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DF281B4-7B36-8F2B-6B3F-9D37F6A57E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BD22A25-8E34-D1C4-2930-820AE332846B}"/>
              </a:ext>
            </a:extLst>
          </p:cNvPr>
          <p:cNvSpPr>
            <a:spLocks noGrp="1"/>
          </p:cNvSpPr>
          <p:nvPr>
            <p:ph type="dt" sz="half" idx="10"/>
          </p:nvPr>
        </p:nvSpPr>
        <p:spPr/>
        <p:txBody>
          <a:bodyPr/>
          <a:lstStyle/>
          <a:p>
            <a:fld id="{F41A258C-CBF1-4C92-8CC3-D379B6AC76EE}" type="datetimeFigureOut">
              <a:rPr lang="en-US" smtClean="0"/>
              <a:t>6/17/2024</a:t>
            </a:fld>
            <a:endParaRPr lang="en-US"/>
          </a:p>
        </p:txBody>
      </p:sp>
      <p:sp>
        <p:nvSpPr>
          <p:cNvPr id="6" name="Footer Placeholder 5">
            <a:extLst>
              <a:ext uri="{FF2B5EF4-FFF2-40B4-BE49-F238E27FC236}">
                <a16:creationId xmlns:a16="http://schemas.microsoft.com/office/drawing/2014/main" id="{5D557A6B-815A-DD66-53B6-AB3F3D027F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CCB70D9-5069-7655-E79A-5748845260B9}"/>
              </a:ext>
            </a:extLst>
          </p:cNvPr>
          <p:cNvSpPr>
            <a:spLocks noGrp="1"/>
          </p:cNvSpPr>
          <p:nvPr>
            <p:ph type="sldNum" sz="quarter" idx="12"/>
          </p:nvPr>
        </p:nvSpPr>
        <p:spPr/>
        <p:txBody>
          <a:bodyPr/>
          <a:lstStyle/>
          <a:p>
            <a:fld id="{68384235-9143-4C7E-84B2-93ED238F725E}" type="slidenum">
              <a:rPr lang="en-US" smtClean="0"/>
              <a:t>‹#›</a:t>
            </a:fld>
            <a:endParaRPr lang="en-US"/>
          </a:p>
        </p:txBody>
      </p:sp>
    </p:spTree>
    <p:extLst>
      <p:ext uri="{BB962C8B-B14F-4D97-AF65-F5344CB8AC3E}">
        <p14:creationId xmlns:p14="http://schemas.microsoft.com/office/powerpoint/2010/main" val="4254553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7414BBD-894C-385A-D567-6C0B6B53F14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48068F9-73FA-FB88-3EB2-16F846A4B0F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43D5B1-9A81-7256-1D9F-8476D7BC23D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41A258C-CBF1-4C92-8CC3-D379B6AC76EE}" type="datetimeFigureOut">
              <a:rPr lang="en-US" smtClean="0"/>
              <a:t>6/17/2024</a:t>
            </a:fld>
            <a:endParaRPr lang="en-US"/>
          </a:p>
        </p:txBody>
      </p:sp>
      <p:sp>
        <p:nvSpPr>
          <p:cNvPr id="5" name="Footer Placeholder 4">
            <a:extLst>
              <a:ext uri="{FF2B5EF4-FFF2-40B4-BE49-F238E27FC236}">
                <a16:creationId xmlns:a16="http://schemas.microsoft.com/office/drawing/2014/main" id="{9937D54C-D07D-4912-F20B-E1F183D1355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0ABAC4CF-0406-64DC-439C-3B2D09426CD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8384235-9143-4C7E-84B2-93ED238F725E}" type="slidenum">
              <a:rPr lang="en-US" smtClean="0"/>
              <a:t>‹#›</a:t>
            </a:fld>
            <a:endParaRPr lang="en-US"/>
          </a:p>
        </p:txBody>
      </p:sp>
    </p:spTree>
    <p:extLst>
      <p:ext uri="{BB962C8B-B14F-4D97-AF65-F5344CB8AC3E}">
        <p14:creationId xmlns:p14="http://schemas.microsoft.com/office/powerpoint/2010/main" val="13260430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A9856061-F1E2-9881-83FB-6C67D4E800E7}"/>
              </a:ext>
            </a:extLst>
          </p:cNvPr>
          <p:cNvSpPr>
            <a:spLocks noGrp="1"/>
          </p:cNvSpPr>
          <p:nvPr>
            <p:ph type="subTitle" idx="1"/>
          </p:nvPr>
        </p:nvSpPr>
        <p:spPr>
          <a:xfrm>
            <a:off x="759069" y="5442437"/>
            <a:ext cx="10673861" cy="1234461"/>
          </a:xfrm>
        </p:spPr>
        <p:txBody>
          <a:bodyPr>
            <a:normAutofit/>
          </a:bodyPr>
          <a:lstStyle/>
          <a:p>
            <a:pPr algn="just">
              <a:lnSpc>
                <a:spcPct val="100000"/>
              </a:lnSpc>
            </a:pPr>
            <a:r>
              <a:rPr lang="en-US" sz="1200" b="1" dirty="0">
                <a:solidFill>
                  <a:srgbClr val="222222"/>
                </a:solidFill>
                <a:latin typeface="Times New Roman" panose="02020603050405020304" pitchFamily="18" charset="0"/>
              </a:rPr>
              <a:t>Fig. 2 </a:t>
            </a:r>
            <a:r>
              <a:rPr lang="en-US" sz="1200" b="1" dirty="0">
                <a:solidFill>
                  <a:srgbClr val="222222"/>
                </a:solidFill>
                <a:effectLst/>
                <a:latin typeface="Times New Roman" panose="02020603050405020304" pitchFamily="18" charset="0"/>
                <a:ea typeface="Times New Roman" panose="02020603050405020304" pitchFamily="18" charset="0"/>
              </a:rPr>
              <a:t>Supplementary: </a:t>
            </a:r>
            <a:r>
              <a:rPr lang="en-US" sz="1200" b="1" dirty="0">
                <a:solidFill>
                  <a:srgbClr val="000000"/>
                </a:solidFill>
                <a:latin typeface="Times New Roman" panose="02020603050405020304" pitchFamily="18" charset="0"/>
                <a:cs typeface="Times New Roman" panose="02020603050405020304" pitchFamily="18" charset="0"/>
              </a:rPr>
              <a:t>Gating strategy used in different T cell subset phenotyping; </a:t>
            </a:r>
            <a:r>
              <a:rPr kumimoji="0" lang="en-US" sz="1300" b="1"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anel A</a:t>
            </a:r>
            <a:r>
              <a:rPr kumimoji="0" lang="en-US" sz="13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The gating strategy used for the analysis included gating lymphocyte single cell splenocytes using forward (FSC) and Side (SSC) scatter parameters of width (W) and height (H) to exclude doublet cells followed by gating on the live and dead cell populations then from live and dead cells CD45+ gate was drilled. </a:t>
            </a:r>
            <a:r>
              <a:rPr kumimoji="0" lang="en-US" sz="1200" b="1"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anel B</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Live and dead CD45+cell gates were drilled down to obtain CD3+</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TCRγδ+ and CD3+TCR</a:t>
            </a:r>
            <a:r>
              <a:rPr lang="el-GR"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αβ</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nd each gate of them was further drilled down to CD4+ cells and CD8</a:t>
            </a:r>
            <a:r>
              <a:rPr lang="el-GR"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β</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cells. </a:t>
            </a:r>
            <a:r>
              <a:rPr lang="en-US" sz="1200" b="1"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anel C</a:t>
            </a:r>
            <a:r>
              <a:rPr lang="en-US" sz="1200"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Live and dead CD45+cell gates were drilled down to obtain CD3</a:t>
            </a:r>
            <a:r>
              <a:rPr kumimoji="0" lang="en-US" sz="1200" b="0" i="0" u="none" strike="noStrike" kern="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cells, which was further drilled to CD8</a:t>
            </a:r>
            <a:r>
              <a:rPr lang="el-GR"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β</a:t>
            </a:r>
            <a:r>
              <a:rPr kumimoji="0" lang="en-US" sz="1200" b="0" i="0" u="none" strike="noStrike" kern="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T cells.</a:t>
            </a:r>
            <a:endParaRPr lang="en-US" sz="1200" dirty="0">
              <a:latin typeface="Times New Roman" panose="02020603050405020304" pitchFamily="18" charset="0"/>
              <a:cs typeface="Times New Roman" panose="02020603050405020304" pitchFamily="18" charset="0"/>
            </a:endParaRPr>
          </a:p>
          <a:p>
            <a:endParaRPr lang="en-US" dirty="0"/>
          </a:p>
        </p:txBody>
      </p:sp>
      <p:sp>
        <p:nvSpPr>
          <p:cNvPr id="11" name="TextBox 10">
            <a:extLst>
              <a:ext uri="{FF2B5EF4-FFF2-40B4-BE49-F238E27FC236}">
                <a16:creationId xmlns:a16="http://schemas.microsoft.com/office/drawing/2014/main" id="{BB4393C6-39AB-2D2A-0711-E18EAB530166}"/>
              </a:ext>
            </a:extLst>
          </p:cNvPr>
          <p:cNvSpPr txBox="1"/>
          <p:nvPr/>
        </p:nvSpPr>
        <p:spPr>
          <a:xfrm>
            <a:off x="70338" y="158262"/>
            <a:ext cx="1257300"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Panel 2</a:t>
            </a:r>
          </a:p>
        </p:txBody>
      </p:sp>
      <p:grpSp>
        <p:nvGrpSpPr>
          <p:cNvPr id="17" name="Group 16">
            <a:extLst>
              <a:ext uri="{FF2B5EF4-FFF2-40B4-BE49-F238E27FC236}">
                <a16:creationId xmlns:a16="http://schemas.microsoft.com/office/drawing/2014/main" id="{8337366E-D930-70C6-AF64-51C09660300D}"/>
              </a:ext>
            </a:extLst>
          </p:cNvPr>
          <p:cNvGrpSpPr/>
          <p:nvPr/>
        </p:nvGrpSpPr>
        <p:grpSpPr>
          <a:xfrm>
            <a:off x="1327638" y="0"/>
            <a:ext cx="8291147" cy="5442438"/>
            <a:chOff x="1002577" y="61546"/>
            <a:chExt cx="9143993" cy="8348024"/>
          </a:xfrm>
        </p:grpSpPr>
        <p:pic>
          <p:nvPicPr>
            <p:cNvPr id="5" name="Picture 4" descr="A collage of images of a person's body&#10;&#10;Description automatically generated">
              <a:extLst>
                <a:ext uri="{FF2B5EF4-FFF2-40B4-BE49-F238E27FC236}">
                  <a16:creationId xmlns:a16="http://schemas.microsoft.com/office/drawing/2014/main" id="{FCC202E3-344F-4A8B-6AD9-6A9AE714944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02577" y="61546"/>
              <a:ext cx="9143993" cy="8348024"/>
            </a:xfrm>
            <a:prstGeom prst="rect">
              <a:avLst/>
            </a:prstGeom>
          </p:spPr>
        </p:pic>
        <p:sp>
          <p:nvSpPr>
            <p:cNvPr id="6" name="Arrow: Right 5">
              <a:extLst>
                <a:ext uri="{FF2B5EF4-FFF2-40B4-BE49-F238E27FC236}">
                  <a16:creationId xmlns:a16="http://schemas.microsoft.com/office/drawing/2014/main" id="{5E4D75BA-1259-E086-72D9-E59609CBEF04}"/>
                </a:ext>
              </a:extLst>
            </p:cNvPr>
            <p:cNvSpPr/>
            <p:nvPr/>
          </p:nvSpPr>
          <p:spPr>
            <a:xfrm>
              <a:off x="3672506" y="4314718"/>
              <a:ext cx="745433" cy="115197"/>
            </a:xfrm>
            <a:prstGeom prst="rightArrow">
              <a:avLst/>
            </a:prstGeom>
            <a:solidFill>
              <a:schemeClr val="accent2">
                <a:lumMod val="75000"/>
              </a:schemeClr>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Arrow: Right 6">
              <a:extLst>
                <a:ext uri="{FF2B5EF4-FFF2-40B4-BE49-F238E27FC236}">
                  <a16:creationId xmlns:a16="http://schemas.microsoft.com/office/drawing/2014/main" id="{947B67F9-741C-9524-9621-A48EAF488DA8}"/>
                </a:ext>
              </a:extLst>
            </p:cNvPr>
            <p:cNvSpPr/>
            <p:nvPr/>
          </p:nvSpPr>
          <p:spPr>
            <a:xfrm rot="20122106">
              <a:off x="6696203" y="3506901"/>
              <a:ext cx="881304" cy="83369"/>
            </a:xfrm>
            <a:prstGeom prst="rightArrow">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Right 7">
              <a:extLst>
                <a:ext uri="{FF2B5EF4-FFF2-40B4-BE49-F238E27FC236}">
                  <a16:creationId xmlns:a16="http://schemas.microsoft.com/office/drawing/2014/main" id="{7DF38802-9B99-4982-30D2-D31792F5E534}"/>
                </a:ext>
              </a:extLst>
            </p:cNvPr>
            <p:cNvSpPr/>
            <p:nvPr/>
          </p:nvSpPr>
          <p:spPr>
            <a:xfrm rot="1306670">
              <a:off x="6708430" y="4664350"/>
              <a:ext cx="902641" cy="117056"/>
            </a:xfrm>
            <a:prstGeom prst="rightArrow">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Right 8">
              <a:extLst>
                <a:ext uri="{FF2B5EF4-FFF2-40B4-BE49-F238E27FC236}">
                  <a16:creationId xmlns:a16="http://schemas.microsoft.com/office/drawing/2014/main" id="{75649CD6-2E70-141C-B33A-7F9B2BB505F8}"/>
                </a:ext>
              </a:extLst>
            </p:cNvPr>
            <p:cNvSpPr/>
            <p:nvPr/>
          </p:nvSpPr>
          <p:spPr>
            <a:xfrm rot="5400000">
              <a:off x="2664478" y="5546382"/>
              <a:ext cx="516772" cy="133034"/>
            </a:xfrm>
            <a:prstGeom prst="rightArrow">
              <a:avLst/>
            </a:prstGeom>
            <a:solidFill>
              <a:schemeClr val="accent2">
                <a:lumMod val="75000"/>
              </a:schemeClr>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Arrow: Right 9">
              <a:extLst>
                <a:ext uri="{FF2B5EF4-FFF2-40B4-BE49-F238E27FC236}">
                  <a16:creationId xmlns:a16="http://schemas.microsoft.com/office/drawing/2014/main" id="{C6CAAD16-4266-1D22-1D51-5FE58F45EFBD}"/>
                </a:ext>
              </a:extLst>
            </p:cNvPr>
            <p:cNvSpPr/>
            <p:nvPr/>
          </p:nvSpPr>
          <p:spPr>
            <a:xfrm>
              <a:off x="3789737" y="7112971"/>
              <a:ext cx="536075" cy="107034"/>
            </a:xfrm>
            <a:prstGeom prst="rightArrow">
              <a:avLst/>
            </a:prstGeom>
            <a:solidFill>
              <a:schemeClr val="accent2">
                <a:lumMod val="75000"/>
              </a:schemeClr>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B3065068-D98B-2E3A-0D3D-28EBB7305FEC}"/>
                </a:ext>
              </a:extLst>
            </p:cNvPr>
            <p:cNvSpPr txBox="1"/>
            <p:nvPr/>
          </p:nvSpPr>
          <p:spPr>
            <a:xfrm>
              <a:off x="1002578" y="527594"/>
              <a:ext cx="325060"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D00A12D3-44A4-8558-6B5E-922C2E5BBB85}"/>
                </a:ext>
              </a:extLst>
            </p:cNvPr>
            <p:cNvSpPr txBox="1"/>
            <p:nvPr/>
          </p:nvSpPr>
          <p:spPr>
            <a:xfrm>
              <a:off x="2523392" y="5357938"/>
              <a:ext cx="326676" cy="369331"/>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sp>
          <p:nvSpPr>
            <p:cNvPr id="14" name="TextBox 13">
              <a:extLst>
                <a:ext uri="{FF2B5EF4-FFF2-40B4-BE49-F238E27FC236}">
                  <a16:creationId xmlns:a16="http://schemas.microsoft.com/office/drawing/2014/main" id="{28C7994D-0C60-9A84-CCD0-44A473A0D685}"/>
                </a:ext>
              </a:extLst>
            </p:cNvPr>
            <p:cNvSpPr txBox="1"/>
            <p:nvPr/>
          </p:nvSpPr>
          <p:spPr>
            <a:xfrm>
              <a:off x="3816881" y="3897007"/>
              <a:ext cx="325060"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32631522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4</TotalTime>
  <Words>158</Words>
  <Application>Microsoft Office PowerPoint</Application>
  <PresentationFormat>Widescreen</PresentationFormat>
  <Paragraphs>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Nagwa Khaled</dc:creator>
  <cp:lastModifiedBy>Nagwa Khaled</cp:lastModifiedBy>
  <cp:revision>4</cp:revision>
  <dcterms:created xsi:type="dcterms:W3CDTF">2024-06-14T20:24:08Z</dcterms:created>
  <dcterms:modified xsi:type="dcterms:W3CDTF">2024-06-17T14:27:25Z</dcterms:modified>
</cp:coreProperties>
</file>